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72" d="100"/>
          <a:sy n="72" d="100"/>
        </p:scale>
        <p:origin x="364" y="6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DB51AA-6C43-477D-9E6D-735A6D49F45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0AB0CC9-AA93-447D-9252-574CBFB2F5D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C4D43E-1424-457E-BE95-EA1093E201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DFAF60-E1C5-467F-8EE6-3BCD13C3310E}" type="datetimeFigureOut">
              <a:rPr lang="en-GB" smtClean="0"/>
              <a:t>27/01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FF43E5F-017E-461E-B91B-7CEFF06BF2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0F2E84D-211F-4478-B02F-5314370121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EE452-BF6A-439C-A26D-0E10F73AF4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63814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D086A8-0BC7-46DC-8D8A-D209731FE1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A64991D-DBE3-40C7-8B21-45DAD27A429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D07017-ACC9-4DE4-93E8-D129626A08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DFAF60-E1C5-467F-8EE6-3BCD13C3310E}" type="datetimeFigureOut">
              <a:rPr lang="en-GB" smtClean="0"/>
              <a:t>27/01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E67BAD-050F-4319-B359-6F41B80855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B6081A-EEBC-4398-9D15-46DB326269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EE452-BF6A-439C-A26D-0E10F73AF4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79052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F7AEF4A-ADE3-4814-BC4A-BAC1107FFDD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40694F3-F2B4-433D-8D0D-3F1478850F3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7EBCE3-599F-43C1-A3A6-324F241522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DFAF60-E1C5-467F-8EE6-3BCD13C3310E}" type="datetimeFigureOut">
              <a:rPr lang="en-GB" smtClean="0"/>
              <a:t>27/01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567EEF-6E91-4172-A6C2-AEDE0011E1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BA798B-163E-45FA-BEAD-8F515E19CD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EE452-BF6A-439C-A26D-0E10F73AF4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090571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FFAD97-FE0E-4DC8-807B-2AFF625AF5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4D6DA7E-1DA4-4A36-92C5-1EDACCA7FF4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FABB850-A78B-4D01-8EB2-774648DB4D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DFAF60-E1C5-467F-8EE6-3BCD13C3310E}" type="datetimeFigureOut">
              <a:rPr lang="en-GB" smtClean="0"/>
              <a:t>27/01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0D8AF55-46BF-4F09-85AB-3332A3A2E3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82CF74-0819-4EAB-A4AC-716C87E18E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EE452-BF6A-439C-A26D-0E10F73AF4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065141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D194A9-3208-4E81-A59C-2C07C4BF8A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589E0F2-202F-4D86-81A4-CD9905435D3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55E00A-A793-4DBB-A4D8-4A1B068CE8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DFAF60-E1C5-467F-8EE6-3BCD13C3310E}" type="datetimeFigureOut">
              <a:rPr lang="en-GB" smtClean="0"/>
              <a:t>27/01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D5A3255-5869-4B51-843F-78D6F9DC37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3D1E28-9D9D-4B67-825D-D363EEC6CC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EE452-BF6A-439C-A26D-0E10F73AF4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892709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32A5CA-8E8A-4056-A49B-0B7CD23EC7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220FDE1-0626-485A-8F46-FC222B26122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FB61468-DB4B-4789-9153-300C143B0CA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F4B3F0F-49D1-4335-B0A9-BC38B66DA8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DFAF60-E1C5-467F-8EE6-3BCD13C3310E}" type="datetimeFigureOut">
              <a:rPr lang="en-GB" smtClean="0"/>
              <a:t>27/01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DD74A0E-5FA5-475F-A0F7-9E7C32CD38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064208F-069C-4F77-91F2-93AE112BD2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EE452-BF6A-439C-A26D-0E10F73AF4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94046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A8A4DD-85BD-4F34-BAB3-74AFBCF660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D25B246-9157-4745-8A3C-5B8CD116EFB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C3AF62D-E32D-44A0-AE4B-655BF6EB8BE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092047B-0EF2-45BC-93A9-A2E15E72B02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587E935-A6A2-48F2-838B-4C1FBFB03D8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513636E-4CB6-48FD-BD11-34329BC04F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DFAF60-E1C5-467F-8EE6-3BCD13C3310E}" type="datetimeFigureOut">
              <a:rPr lang="en-GB" smtClean="0"/>
              <a:t>27/01/2022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D8A4C70-9C8A-423B-BB48-919652C9FD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539D75F-D745-47E5-849B-BA4034FC0C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EE452-BF6A-439C-A26D-0E10F73AF4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69584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32DA2B-9C00-439F-B448-620A0B0F01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1AB4C15-824E-49AB-BF1A-FB89C58E7F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DFAF60-E1C5-467F-8EE6-3BCD13C3310E}" type="datetimeFigureOut">
              <a:rPr lang="en-GB" smtClean="0"/>
              <a:t>27/01/2022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9857004-1170-46A0-AC0A-BB0CA16852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905CC06-B630-4A27-B43F-4B76FB470A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EE452-BF6A-439C-A26D-0E10F73AF4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53908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5145707-3D27-4316-8A9C-889BC6EDFA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DFAF60-E1C5-467F-8EE6-3BCD13C3310E}" type="datetimeFigureOut">
              <a:rPr lang="en-GB" smtClean="0"/>
              <a:t>27/01/2022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B33AE01-989D-40DB-8EA3-F18174F2EC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5591044-66B5-4CD4-9C62-329CC52989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EE452-BF6A-439C-A26D-0E10F73AF4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494798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4A9112-4445-4BC0-A003-84001F0915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4D03EB9-CF37-4FBE-BF42-9C6F23BD6A7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98C745A-A1AD-46DE-BA8D-601BAA54987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351E278-396E-45EC-B366-A57B7EBCE7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DFAF60-E1C5-467F-8EE6-3BCD13C3310E}" type="datetimeFigureOut">
              <a:rPr lang="en-GB" smtClean="0"/>
              <a:t>27/01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DBB4B62-E9FD-4BBD-A64F-400F841E3A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E5C5325-2F11-4F16-A60B-80906E2530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EE452-BF6A-439C-A26D-0E10F73AF4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11701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E29859-9C93-42A8-AEA0-503D5FF66D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C535CC8-29C3-43B9-95A2-6230CAE7827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5F927EE-B410-4D46-9515-0C3ED50B79A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14568BA-1448-44FC-9457-4185B322CE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DFAF60-E1C5-467F-8EE6-3BCD13C3310E}" type="datetimeFigureOut">
              <a:rPr lang="en-GB" smtClean="0"/>
              <a:t>27/01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33660AD-C09F-429F-AD42-7F564DCC07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2F879EF-4CBB-49F8-8D88-8FB6FECAC7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EE452-BF6A-439C-A26D-0E10F73AF4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265526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9D554EA-F056-4158-9D13-5DBB70D359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44D3216-1618-4620-9625-D3B42D5D61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6FFE04-0D9F-428C-86F3-C8AC087769C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DFAF60-E1C5-467F-8EE6-3BCD13C3310E}" type="datetimeFigureOut">
              <a:rPr lang="en-GB" smtClean="0"/>
              <a:t>27/01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8653B1-91B7-46DF-97A5-0445D7D4FCA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0B7003-30F1-44BC-BCC9-2786D027AF7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0EE452-BF6A-439C-A26D-0E10F73AF4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79328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graphical user interface&#10;&#10;Description automatically generated">
            <a:extLst>
              <a:ext uri="{FF2B5EF4-FFF2-40B4-BE49-F238E27FC236}">
                <a16:creationId xmlns:a16="http://schemas.microsoft.com/office/drawing/2014/main" id="{77F336F5-4ACA-4FA8-B35E-6DE69762FA2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8AC3B75C-1510-4DD1-B647-CA050A5E8CCB}"/>
              </a:ext>
            </a:extLst>
          </p:cNvPr>
          <p:cNvSpPr txBox="1"/>
          <p:nvPr/>
        </p:nvSpPr>
        <p:spPr>
          <a:xfrm>
            <a:off x="153138" y="6016016"/>
            <a:ext cx="11307933" cy="3755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800" b="1" dirty="0">
                <a:solidFill>
                  <a:srgbClr val="333333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Figure 1: </a:t>
            </a:r>
            <a:r>
              <a:rPr lang="en-GB" sz="1800" dirty="0">
                <a:solidFill>
                  <a:srgbClr val="333333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ombinations of resistance associated mutations (RAMs) and number of isolates.</a:t>
            </a:r>
            <a:endParaRPr lang="en-GB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735233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eeba Basil</dc:creator>
  <cp:lastModifiedBy>Sheeba Basil</cp:lastModifiedBy>
  <cp:revision>1</cp:revision>
  <dcterms:created xsi:type="dcterms:W3CDTF">2022-01-27T11:33:43Z</dcterms:created>
  <dcterms:modified xsi:type="dcterms:W3CDTF">2022-01-27T11:34:14Z</dcterms:modified>
</cp:coreProperties>
</file>